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2" r:id="rId2"/>
    <p:sldId id="271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A2B537E-656A-2644-B112-9B080337D6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59DADCC-AE84-1149-8E69-040C4DBAF8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0F4CFFB-F369-B243-9BB4-86B629AD7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4A28DF-4225-CE4F-B1EA-E7A156193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71D1DA9-FE90-5F45-8434-DB501D3DB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8838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0E16A7-E39C-3F44-BE85-C2266E141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3AF3A0F-84F2-784B-9C75-83AD45EE9C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16DC-258F-1D4C-BA1A-9FBF8BE6E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389936A-C15A-4641-B8A6-56232B34D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E7835A-5B4E-E448-87BD-6864E04DD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7826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2F03579-22C0-3F43-90AA-964D0DAA70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6383103-9409-1C4B-9F3C-83A6976CC8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AB76CE-8616-D141-8FA2-3D2C7D567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25E1716-136B-7843-9E2B-CF132191A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B75CA6-75B1-6549-9B23-C48E4D5E2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588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0B94AA-8074-824A-98E5-A2A078619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626E964-4F8C-3B43-A1FD-B88D985D34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D668A41-264C-6646-BFA0-374DDC7E1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39F2AA-C593-7146-9DDD-F7F48E943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F27E118-B5CA-DB4B-BE8A-3538A1F12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1126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5CC9BB6-132D-4D45-B288-C21407031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F0118A6-333E-3949-8D11-A73CAB71D1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A6FF426-A4F1-C049-B946-7132006CB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D183CE-290A-7F41-BED4-D9D799F1C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F09FEB-5AF7-6F4A-97B7-33E2135AD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9933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808805-39FC-0640-87EE-65BD661C76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9B4DB73-0841-1749-BEB7-BCF8C677F7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124D78D-9891-4544-B1A1-21705F9B4C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702C9E4-A1F2-3F40-BAC5-C893D6EEC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1ACCB60-2EB2-B949-9E33-372DFABE9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7ADF0CE-2018-E048-9C03-32617A366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7199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1FA18E2-9BA4-6E4A-BE78-76AA4A729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A2DB502-DF5E-E940-B31C-4AE0041C8D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D576DCA-B4BA-794C-82F6-1AB5AB47D7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E11D548-C338-2B48-AA13-3FB23CB44D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D01755A-6B3D-174C-A6F5-622D64E254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DE856AD-BE3D-6D4F-91B9-CD9ED29B0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51FE602-3921-9044-8DAB-9FE35AF2D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E66B5D6-62C5-2746-9AD6-533224673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582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88290B-D80E-4C4B-BE82-E160B2BF2C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0F486E5-6128-3F4A-8997-40CB75671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4748707-2911-C54B-8A50-CC730A156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321015A-D5C4-0A43-9C52-0CC8AA271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8940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60C087B-914F-EB43-A9AA-05174870A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F37ABBD-7E8A-A84D-918F-CE38FEA57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89A5704-C672-E543-B0BF-376240F36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28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38F2DE-B1F7-6B4C-81AD-95E555E2FB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85F7ADE-574D-BC48-943F-30DE609BEB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05E4743-39CC-774E-A29A-2BA094A20C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C2AD6EB-7C23-3C4B-811E-477E2D09C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2EB5C8C-D8B0-8C46-88B4-DCB351B20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31ABB9E-A772-E147-BB7D-080FBA302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6232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0271C9-05B3-5941-8DFA-584688B45E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2328050-03A7-B345-8786-47A23FDE77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7638866-8646-1747-8426-EE4CA6854A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F831057-E4BE-9F4C-A5FC-D1D30FC1F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88D8026-31C7-5246-B5F0-CD7FE6A3F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EE83073-4F6B-314D-8037-02E01DADF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1711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57EBD34-6B6E-C840-A9B4-EAFB11671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6C44BBF-0779-2A4F-8BF2-FA449137C4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F2507E-0035-404E-9AE5-0F87A9475F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59D68-4091-1742-9BE2-58FC6CA98796}" type="datetimeFigureOut">
              <a:t>11/03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9FCE90F-4A5F-0545-A306-53ABC8B210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A7FA9D-972C-5D40-A295-6B6E32F9C9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F1E2D-103D-E142-878F-AF65781C43BA}" type="slidenum"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0867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F0DD-E6EE-48E7-ACDE-BBC67DC5B64D}" type="slidenum">
              <a:rPr lang="fr-FR" smtClean="0"/>
              <a:t>1</a:t>
            </a:fld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7270835" y="4063243"/>
            <a:ext cx="1895872" cy="1760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6249F9B2-5116-41D6-865A-7D2724B3770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757995" y="230820"/>
            <a:ext cx="7176118" cy="4197722"/>
          </a:xfrm>
          <a:prstGeom prst="rect">
            <a:avLst/>
          </a:prstGeom>
        </p:spPr>
      </p:pic>
      <p:graphicFrame>
        <p:nvGraphicFramePr>
          <p:cNvPr id="12" name="Tableau 11">
            <a:extLst>
              <a:ext uri="{FF2B5EF4-FFF2-40B4-BE49-F238E27FC236}">
                <a16:creationId xmlns:a16="http://schemas.microsoft.com/office/drawing/2014/main" id="{4750D3C1-91D6-4082-BCAE-54F53DDDF08D}"/>
              </a:ext>
            </a:extLst>
          </p:cNvPr>
          <p:cNvGraphicFramePr>
            <a:graphicFrameLocks noGrp="1"/>
          </p:cNvGraphicFramePr>
          <p:nvPr/>
        </p:nvGraphicFramePr>
        <p:xfrm>
          <a:off x="2180334" y="4727941"/>
          <a:ext cx="8134097" cy="1981200"/>
        </p:xfrm>
        <a:graphic>
          <a:graphicData uri="http://schemas.openxmlformats.org/drawingml/2006/table">
            <a:tbl>
              <a:tblPr firstRow="1" bandRow="1">
                <a:tableStyleId>{00A15C55-8517-42AA-B614-E9B94910E393}</a:tableStyleId>
              </a:tblPr>
              <a:tblGrid>
                <a:gridCol w="3674174">
                  <a:extLst>
                    <a:ext uri="{9D8B030D-6E8A-4147-A177-3AD203B41FA5}">
                      <a16:colId xmlns:a16="http://schemas.microsoft.com/office/drawing/2014/main" val="4252787276"/>
                    </a:ext>
                  </a:extLst>
                </a:gridCol>
                <a:gridCol w="1851343">
                  <a:extLst>
                    <a:ext uri="{9D8B030D-6E8A-4147-A177-3AD203B41FA5}">
                      <a16:colId xmlns:a16="http://schemas.microsoft.com/office/drawing/2014/main" val="523076217"/>
                    </a:ext>
                  </a:extLst>
                </a:gridCol>
                <a:gridCol w="2608580">
                  <a:extLst>
                    <a:ext uri="{9D8B030D-6E8A-4147-A177-3AD203B41FA5}">
                      <a16:colId xmlns:a16="http://schemas.microsoft.com/office/drawing/2014/main" val="229444531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20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20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25531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Total reques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>
                          <a:effectLst/>
                        </a:rPr>
                        <a:t>369,317</a:t>
                      </a:r>
                      <a:endParaRPr lang="fr-FR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>
                          <a:effectLst/>
                        </a:rPr>
                        <a:t>3,549,488</a:t>
                      </a:r>
                      <a:endParaRPr lang="fr-FR" sz="2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0891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Number of request per 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796 [578 – 989]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11,125 [5592 – 12 505]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27187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Unique I.P. address / 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414 [245 – 394]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dirty="0"/>
                        <a:t>5365    [2891 – 5769]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80024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2000" dirty="0"/>
                        <a:t>Requests / 100 unique I.P. / 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196 [184 – 243]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fr-FR" sz="2000" dirty="0"/>
                        <a:t>212       [203 – 220]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5947689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C96E8E6B-780D-A549-837A-DD2C38A84E1B}"/>
              </a:ext>
            </a:extLst>
          </p:cNvPr>
          <p:cNvSpPr/>
          <p:nvPr/>
        </p:nvSpPr>
        <p:spPr>
          <a:xfrm>
            <a:off x="3074800" y="27619"/>
            <a:ext cx="5023042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Number of requests per month, from 2015 to 2018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D8C22E7-439D-274B-96F4-0AAEC19519DA}"/>
              </a:ext>
            </a:extLst>
          </p:cNvPr>
          <p:cNvSpPr/>
          <p:nvPr/>
        </p:nvSpPr>
        <p:spPr>
          <a:xfrm>
            <a:off x="2180337" y="3223534"/>
            <a:ext cx="94609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100,000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DEB0481-2CB4-674F-8447-99773E78EB6A}"/>
              </a:ext>
            </a:extLst>
          </p:cNvPr>
          <p:cNvSpPr/>
          <p:nvPr/>
        </p:nvSpPr>
        <p:spPr>
          <a:xfrm>
            <a:off x="2297357" y="3936296"/>
            <a:ext cx="82907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50,00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EE9E2B5-E99D-124B-9351-BA5B8B24BB4C}"/>
              </a:ext>
            </a:extLst>
          </p:cNvPr>
          <p:cNvSpPr/>
          <p:nvPr/>
        </p:nvSpPr>
        <p:spPr>
          <a:xfrm>
            <a:off x="2711893" y="1718743"/>
            <a:ext cx="167709" cy="10901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endParaRPr lang="fr-FR" b="1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F8CD084-10A8-3345-A41A-E7B14713CFAE}"/>
              </a:ext>
            </a:extLst>
          </p:cNvPr>
          <p:cNvSpPr/>
          <p:nvPr/>
        </p:nvSpPr>
        <p:spPr>
          <a:xfrm>
            <a:off x="2180336" y="2537039"/>
            <a:ext cx="94609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150,000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798A7DA-7C86-6F4F-A048-3A7F2D00F862}"/>
              </a:ext>
            </a:extLst>
          </p:cNvPr>
          <p:cNvSpPr/>
          <p:nvPr/>
        </p:nvSpPr>
        <p:spPr>
          <a:xfrm>
            <a:off x="2180336" y="1790885"/>
            <a:ext cx="94609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00,000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C2E9BF9-758D-CB4C-9556-CBF83F36D4BA}"/>
              </a:ext>
            </a:extLst>
          </p:cNvPr>
          <p:cNvSpPr/>
          <p:nvPr/>
        </p:nvSpPr>
        <p:spPr>
          <a:xfrm>
            <a:off x="2180335" y="1069519"/>
            <a:ext cx="94609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50,000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5426F28-1F02-E24B-A150-F0390C5E524D}"/>
              </a:ext>
            </a:extLst>
          </p:cNvPr>
          <p:cNvSpPr/>
          <p:nvPr/>
        </p:nvSpPr>
        <p:spPr>
          <a:xfrm>
            <a:off x="2180334" y="356757"/>
            <a:ext cx="94609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300,000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82D4203-EF19-434C-BE9C-DD4D7ADED460}"/>
              </a:ext>
            </a:extLst>
          </p:cNvPr>
          <p:cNvSpPr/>
          <p:nvPr/>
        </p:nvSpPr>
        <p:spPr>
          <a:xfrm>
            <a:off x="3173506" y="4165890"/>
            <a:ext cx="6808694" cy="2110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DD1DDE1-E336-EF47-969F-8BB2F30A959A}"/>
              </a:ext>
            </a:extLst>
          </p:cNvPr>
          <p:cNvSpPr/>
          <p:nvPr/>
        </p:nvSpPr>
        <p:spPr>
          <a:xfrm>
            <a:off x="3854085" y="4257576"/>
            <a:ext cx="65274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015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0C33740-B4EC-9644-AC08-49D8D7B5E1AF}"/>
              </a:ext>
            </a:extLst>
          </p:cNvPr>
          <p:cNvSpPr/>
          <p:nvPr/>
        </p:nvSpPr>
        <p:spPr>
          <a:xfrm>
            <a:off x="5645235" y="4264422"/>
            <a:ext cx="65274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016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7A85CA0-535D-884D-B856-36E4DCA2F6AE}"/>
              </a:ext>
            </a:extLst>
          </p:cNvPr>
          <p:cNvSpPr/>
          <p:nvPr/>
        </p:nvSpPr>
        <p:spPr>
          <a:xfrm>
            <a:off x="7129269" y="4264422"/>
            <a:ext cx="65274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017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9E09847-9746-A245-9114-AE6259D7E9A7}"/>
              </a:ext>
            </a:extLst>
          </p:cNvPr>
          <p:cNvSpPr/>
          <p:nvPr/>
        </p:nvSpPr>
        <p:spPr>
          <a:xfrm>
            <a:off x="8679410" y="4253101"/>
            <a:ext cx="652743" cy="369332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fr-FR" b="1" dirty="0"/>
              <a:t>2018</a:t>
            </a:r>
          </a:p>
        </p:txBody>
      </p:sp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02E676DD-E7C1-AA46-A60B-E4BF820EB5D9}"/>
              </a:ext>
            </a:extLst>
          </p:cNvPr>
          <p:cNvCxnSpPr/>
          <p:nvPr/>
        </p:nvCxnSpPr>
        <p:spPr>
          <a:xfrm>
            <a:off x="3461959" y="4163389"/>
            <a:ext cx="0" cy="101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AD604543-7787-804D-85DA-1A5D66BF34B5}"/>
              </a:ext>
            </a:extLst>
          </p:cNvPr>
          <p:cNvCxnSpPr/>
          <p:nvPr/>
        </p:nvCxnSpPr>
        <p:spPr>
          <a:xfrm>
            <a:off x="5087559" y="4154090"/>
            <a:ext cx="0" cy="101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85FF5B68-2FF6-9F49-A590-A1902BEB2D08}"/>
              </a:ext>
            </a:extLst>
          </p:cNvPr>
          <p:cNvCxnSpPr/>
          <p:nvPr/>
        </p:nvCxnSpPr>
        <p:spPr>
          <a:xfrm>
            <a:off x="6677599" y="4156543"/>
            <a:ext cx="0" cy="101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EC26CBCC-2870-6445-BBA6-03D004764613}"/>
              </a:ext>
            </a:extLst>
          </p:cNvPr>
          <p:cNvCxnSpPr/>
          <p:nvPr/>
        </p:nvCxnSpPr>
        <p:spPr>
          <a:xfrm>
            <a:off x="8218771" y="4162442"/>
            <a:ext cx="0" cy="101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43ABFC36-178D-D743-8640-87B8431BB41A}"/>
              </a:ext>
            </a:extLst>
          </p:cNvPr>
          <p:cNvCxnSpPr/>
          <p:nvPr/>
        </p:nvCxnSpPr>
        <p:spPr>
          <a:xfrm>
            <a:off x="9722451" y="4156543"/>
            <a:ext cx="0" cy="101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00468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81200" y="274638"/>
            <a:ext cx="8229600" cy="1143000"/>
          </a:xfrm>
        </p:spPr>
        <p:txBody>
          <a:bodyPr>
            <a:normAutofit/>
          </a:bodyPr>
          <a:lstStyle/>
          <a:p>
            <a:r>
              <a:rPr lang="fr-FR" sz="3400" dirty="0"/>
              <a:t>Location of use in France</a:t>
            </a: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2F0DD-E6EE-48E7-ACDE-BBC67DC5B64D}" type="slidenum">
              <a:rPr lang="fr-FR" smtClean="0"/>
              <a:t>2</a:t>
            </a:fld>
            <a:endParaRPr lang="fr-FR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E0BE6832-A10F-4251-9914-7BD7FD8189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808" t="35993" r="29525" b="23388"/>
          <a:stretch/>
        </p:blipFill>
        <p:spPr>
          <a:xfrm>
            <a:off x="3009525" y="1739427"/>
            <a:ext cx="6172950" cy="4451775"/>
          </a:xfrm>
          <a:prstGeom prst="rect">
            <a:avLst/>
          </a:prstGeom>
        </p:spPr>
      </p:pic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470E00F2-C2A3-4F3D-B4D6-9EDDD7FB5665}"/>
              </a:ext>
            </a:extLst>
          </p:cNvPr>
          <p:cNvCxnSpPr>
            <a:cxnSpLocks/>
          </p:cNvCxnSpPr>
          <p:nvPr/>
        </p:nvCxnSpPr>
        <p:spPr>
          <a:xfrm>
            <a:off x="1981200" y="1196752"/>
            <a:ext cx="8229600" cy="0"/>
          </a:xfrm>
          <a:prstGeom prst="line">
            <a:avLst/>
          </a:prstGeom>
          <a:ln w="635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>
            <a:extLst>
              <a:ext uri="{FF2B5EF4-FFF2-40B4-BE49-F238E27FC236}">
                <a16:creationId xmlns:a16="http://schemas.microsoft.com/office/drawing/2014/main" id="{33400538-03E3-994B-A680-87F373247757}"/>
              </a:ext>
            </a:extLst>
          </p:cNvPr>
          <p:cNvSpPr/>
          <p:nvPr/>
        </p:nvSpPr>
        <p:spPr>
          <a:xfrm>
            <a:off x="4805946" y="6006536"/>
            <a:ext cx="20887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dirty="0"/>
              <a:t>Number of requests</a:t>
            </a:r>
            <a:endParaRPr lang="fr-FR" b="1"/>
          </a:p>
        </p:txBody>
      </p:sp>
    </p:spTree>
    <p:extLst>
      <p:ext uri="{BB962C8B-B14F-4D97-AF65-F5344CB8AC3E}">
        <p14:creationId xmlns:p14="http://schemas.microsoft.com/office/powerpoint/2010/main" val="19908412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Macintosh PowerPoint</Application>
  <PresentationFormat>Grand écran</PresentationFormat>
  <Paragraphs>29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Location of use in Franc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than Peiffer-Smadja</dc:creator>
  <cp:lastModifiedBy>Nathan Peiffer-Smadja</cp:lastModifiedBy>
  <cp:revision>1</cp:revision>
  <dcterms:created xsi:type="dcterms:W3CDTF">2020-03-11T13:15:53Z</dcterms:created>
  <dcterms:modified xsi:type="dcterms:W3CDTF">2020-03-11T13:16:16Z</dcterms:modified>
</cp:coreProperties>
</file>